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0CAB1-7B81-4E45-807D-7ACD00538B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865168-78E4-44A2-96F3-B47031444C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3BDC1-898D-4D10-AF45-B97085338E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A73020-04AE-4076-80AA-6B41845CD3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EC8E0-FF31-409E-B571-1BBE100F80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F1F2D-AFDD-4B79-ABAA-AEA056084E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F1285-E5A3-49AF-8E00-BBFB08B47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AFD7C-194F-4D6D-A515-07721E5313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81E14-9C26-46C3-8B48-B5B733A865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3B24B-B2E3-4B85-A309-B484BF242C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07CA2-F4F8-4793-A5D0-78DBAA5D4E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337A0-8C76-421A-8784-7BF0776883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08103A-FC67-4F8B-8D08-FE998FE88EB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87280" y="1341360"/>
          <a:ext cx="6840720" cy="3571920"/>
        </p:xfrm>
        <a:graphic>
          <a:graphicData uri="http://schemas.openxmlformats.org/drawingml/2006/table">
            <a:tbl>
              <a:tblPr/>
              <a:tblGrid>
                <a:gridCol w="617760"/>
                <a:gridCol w="1111320"/>
                <a:gridCol w="3168360"/>
                <a:gridCol w="790920"/>
                <a:gridCol w="1152360"/>
              </a:tblGrid>
              <a:tr h="355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sequence (5’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ze, b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. Temp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1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GATGGAAAGAATTTTATG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CAAACTAACCCCAAATT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C-AGGGTTTTTATAATTTA-MG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1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P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CGGCGAGGAAGTTTT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CTATCGAACGAACGTCTCC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D-CGCGATTCGTTTTTTGTA-MG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1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N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GTAGACGTTTTTAAA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ATCTAAACCCGACTT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IC-CGTTGACGTTGTTCGGAT-MG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70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-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GGGAGTTGTAGCGTAGTAGAGTATT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ACTCCTCGTACCGCAC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FAM-CGGCGTTAGGTTGC-MG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2000">
                <a:tc gridSpan="5">
                  <a:txBody>
                    <a:bodyPr lIns="90000" rIns="90000" tIns="46800" bIns="4680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breviations: MSP, methylation-specific PCR; Fw indicates forward primers; Rv, reverse primers; Pr, TaqMan-MGB probes; M, bisulfite MSP-specific primers; Size, bp, fragment size  in base pairs; An. Temp, annealing temperature (in degrees Celsiu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12T09:03:20Z</dcterms:created>
  <dc:creator>jp roperch</dc:creator>
  <dc:description/>
  <dc:language>en-US</dc:language>
  <cp:lastModifiedBy>jp roperch</cp:lastModifiedBy>
  <dcterms:modified xsi:type="dcterms:W3CDTF">2014-01-20T11:25:00Z</dcterms:modified>
  <cp:revision>20</cp:revision>
  <dc:subject/>
  <dc:title>Diapositive 1</dc:title>
</cp:coreProperties>
</file>